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2" userDrawn="1">
          <p15:clr>
            <a:srgbClr val="A4A3A4"/>
          </p15:clr>
        </p15:guide>
        <p15:guide id="2" pos="1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42"/>
    <p:restoredTop sz="78801"/>
  </p:normalViewPr>
  <p:slideViewPr>
    <p:cSldViewPr snapToGrid="0" snapToObjects="1" showGuides="1">
      <p:cViewPr>
        <p:scale>
          <a:sx n="125" d="100"/>
          <a:sy n="125" d="100"/>
        </p:scale>
        <p:origin x="1472" y="-2232"/>
      </p:cViewPr>
      <p:guideLst>
        <p:guide orient="horz" pos="1442"/>
        <p:guide pos="1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F88827-E046-7441-A0E9-DAAEB26EC332}" type="datetimeFigureOut">
              <a:rPr lang="en-GB" smtClean="0"/>
              <a:t>15/01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EF1FBA-DBF9-2043-819C-A714860AD4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29247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b="1" dirty="0"/>
              <a:t>Supplementary figure 3</a:t>
            </a:r>
            <a:r>
              <a:rPr lang="en-GB" dirty="0"/>
              <a:t>. A, B : (</a:t>
            </a:r>
            <a:r>
              <a:rPr lang="en-GB" dirty="0" err="1"/>
              <a:t>i</a:t>
            </a:r>
            <a:r>
              <a:rPr lang="en-GB" dirty="0"/>
              <a:t>) LC3b I, (ii)II and (iii) LC3bII/I densitometry analyses from western blots performed on 2 independent IPF/control cohorts, C and D : relative mRNA expression of p62 and Beclin1. E.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presentative images of LC3b </a:t>
            </a:r>
            <a:r>
              <a:rPr lang="en-GB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mmunostained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lveolar macrophages from IPF and control samples treated with CQ or left untreated. </a:t>
            </a:r>
            <a:r>
              <a:rPr lang="en-GB" dirty="0"/>
              <a:t>All graphs represent median and interquartile ranges, no significant differences observed according to Mann-Whitney test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9FC3C9E-E111-D74D-80DD-B1DF93E3A59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67451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41486-0DC6-A147-946E-69BCB240DF6D}" type="datetimeFigureOut">
              <a:rPr lang="en-GB" smtClean="0"/>
              <a:t>15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7EACA-2628-804F-A7A3-2FB2ECE4E8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9483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41486-0DC6-A147-946E-69BCB240DF6D}" type="datetimeFigureOut">
              <a:rPr lang="en-GB" smtClean="0"/>
              <a:t>15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7EACA-2628-804F-A7A3-2FB2ECE4E8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0931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41486-0DC6-A147-946E-69BCB240DF6D}" type="datetimeFigureOut">
              <a:rPr lang="en-GB" smtClean="0"/>
              <a:t>15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7EACA-2628-804F-A7A3-2FB2ECE4E8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71903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41486-0DC6-A147-946E-69BCB240DF6D}" type="datetimeFigureOut">
              <a:rPr lang="en-GB" smtClean="0"/>
              <a:t>15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7EACA-2628-804F-A7A3-2FB2ECE4E8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8148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41486-0DC6-A147-946E-69BCB240DF6D}" type="datetimeFigureOut">
              <a:rPr lang="en-GB" smtClean="0"/>
              <a:t>15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7EACA-2628-804F-A7A3-2FB2ECE4E8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35735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41486-0DC6-A147-946E-69BCB240DF6D}" type="datetimeFigureOut">
              <a:rPr lang="en-GB" smtClean="0"/>
              <a:t>15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7EACA-2628-804F-A7A3-2FB2ECE4E8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5865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41486-0DC6-A147-946E-69BCB240DF6D}" type="datetimeFigureOut">
              <a:rPr lang="en-GB" smtClean="0"/>
              <a:t>15/0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7EACA-2628-804F-A7A3-2FB2ECE4E8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19255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41486-0DC6-A147-946E-69BCB240DF6D}" type="datetimeFigureOut">
              <a:rPr lang="en-GB" smtClean="0"/>
              <a:t>15/0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7EACA-2628-804F-A7A3-2FB2ECE4E8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5859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41486-0DC6-A147-946E-69BCB240DF6D}" type="datetimeFigureOut">
              <a:rPr lang="en-GB" smtClean="0"/>
              <a:t>15/0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7EACA-2628-804F-A7A3-2FB2ECE4E8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490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41486-0DC6-A147-946E-69BCB240DF6D}" type="datetimeFigureOut">
              <a:rPr lang="en-GB" smtClean="0"/>
              <a:t>15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7EACA-2628-804F-A7A3-2FB2ECE4E8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3006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41486-0DC6-A147-946E-69BCB240DF6D}" type="datetimeFigureOut">
              <a:rPr lang="en-GB" smtClean="0"/>
              <a:t>15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7EACA-2628-804F-A7A3-2FB2ECE4E8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136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941486-0DC6-A147-946E-69BCB240DF6D}" type="datetimeFigureOut">
              <a:rPr lang="en-GB" smtClean="0"/>
              <a:t>15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37EACA-2628-804F-A7A3-2FB2ECE4E8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8731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emf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5" Type="http://schemas.openxmlformats.org/officeDocument/2006/relationships/image" Target="../media/image3.emf"/><Relationship Id="rId4" Type="http://schemas.openxmlformats.org/officeDocument/2006/relationships/image" Target="../media/image2.emf"/><Relationship Id="rId9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F62DC0B-14FD-C844-A462-4F3238866DD4}"/>
              </a:ext>
            </a:extLst>
          </p:cNvPr>
          <p:cNvSpPr txBox="1"/>
          <p:nvPr/>
        </p:nvSpPr>
        <p:spPr>
          <a:xfrm>
            <a:off x="131885" y="57152"/>
            <a:ext cx="3347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A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71DB282-DCF6-004E-A387-DBE772B8058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69236"/>
          <a:stretch/>
        </p:blipFill>
        <p:spPr>
          <a:xfrm>
            <a:off x="396076" y="149055"/>
            <a:ext cx="6134100" cy="175034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2AD045F-F22D-704A-A6F0-F7992D9018E7}"/>
              </a:ext>
            </a:extLst>
          </p:cNvPr>
          <p:cNvSpPr txBox="1"/>
          <p:nvPr/>
        </p:nvSpPr>
        <p:spPr>
          <a:xfrm>
            <a:off x="552385" y="2011691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(</a:t>
            </a:r>
            <a:r>
              <a:rPr lang="en-GB" sz="1200" dirty="0" err="1"/>
              <a:t>i</a:t>
            </a:r>
            <a:r>
              <a:rPr lang="en-GB" sz="1200" dirty="0"/>
              <a:t>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C86B8ED-F68C-A644-801D-13339E716CA0}"/>
              </a:ext>
            </a:extLst>
          </p:cNvPr>
          <p:cNvSpPr txBox="1"/>
          <p:nvPr/>
        </p:nvSpPr>
        <p:spPr>
          <a:xfrm>
            <a:off x="2478139" y="2024004"/>
            <a:ext cx="348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(ii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B009285-D0C3-2B42-8433-31812753DD81}"/>
              </a:ext>
            </a:extLst>
          </p:cNvPr>
          <p:cNvSpPr txBox="1"/>
          <p:nvPr/>
        </p:nvSpPr>
        <p:spPr>
          <a:xfrm>
            <a:off x="4486524" y="2011690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(iii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11B2728-8BCD-DB44-A33D-89E514613C75}"/>
              </a:ext>
            </a:extLst>
          </p:cNvPr>
          <p:cNvSpPr txBox="1"/>
          <p:nvPr/>
        </p:nvSpPr>
        <p:spPr>
          <a:xfrm>
            <a:off x="552385" y="136742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(</a:t>
            </a:r>
            <a:r>
              <a:rPr lang="en-GB" sz="1200" dirty="0" err="1"/>
              <a:t>i</a:t>
            </a:r>
            <a:r>
              <a:rPr lang="en-GB" sz="1200" dirty="0"/>
              <a:t>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3967E84-D967-F04A-AA57-9A311A266F0F}"/>
              </a:ext>
            </a:extLst>
          </p:cNvPr>
          <p:cNvSpPr txBox="1"/>
          <p:nvPr/>
        </p:nvSpPr>
        <p:spPr>
          <a:xfrm>
            <a:off x="2478139" y="149055"/>
            <a:ext cx="348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(ii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697FD39-7EE5-BE41-836F-F67C5861FE76}"/>
              </a:ext>
            </a:extLst>
          </p:cNvPr>
          <p:cNvSpPr txBox="1"/>
          <p:nvPr/>
        </p:nvSpPr>
        <p:spPr>
          <a:xfrm>
            <a:off x="4486524" y="136741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(iii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514B9DF-0E62-C645-9123-042FD2187F65}"/>
              </a:ext>
            </a:extLst>
          </p:cNvPr>
          <p:cNvSpPr txBox="1"/>
          <p:nvPr/>
        </p:nvSpPr>
        <p:spPr>
          <a:xfrm>
            <a:off x="141877" y="1836046"/>
            <a:ext cx="327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B.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98CB6B1-8702-FB44-B30D-8FBB6C91003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2213" y="4202254"/>
            <a:ext cx="2518720" cy="1975262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A519BFD4-93C1-1C41-8735-459F43039B9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87863" y="4202253"/>
            <a:ext cx="2518720" cy="1975262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EB8E118E-4B8D-A744-BF8E-F875A0190D90}"/>
              </a:ext>
            </a:extLst>
          </p:cNvPr>
          <p:cNvSpPr txBox="1"/>
          <p:nvPr/>
        </p:nvSpPr>
        <p:spPr>
          <a:xfrm>
            <a:off x="869339" y="4048365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C.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5376447-0DA9-8A49-A10D-B8D678F6F2D4}"/>
              </a:ext>
            </a:extLst>
          </p:cNvPr>
          <p:cNvSpPr txBox="1"/>
          <p:nvPr/>
        </p:nvSpPr>
        <p:spPr>
          <a:xfrm>
            <a:off x="3383445" y="4048365"/>
            <a:ext cx="3359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D.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4A2734D6-C0FA-F641-9B8A-0DFAFE4C514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66267"/>
          <a:stretch/>
        </p:blipFill>
        <p:spPr>
          <a:xfrm>
            <a:off x="327827" y="1982563"/>
            <a:ext cx="6134100" cy="191928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1A5BD63-EF2B-CE42-B24D-9264046348EF}"/>
              </a:ext>
            </a:extLst>
          </p:cNvPr>
          <p:cNvSpPr txBox="1"/>
          <p:nvPr/>
        </p:nvSpPr>
        <p:spPr>
          <a:xfrm>
            <a:off x="134470" y="8713693"/>
            <a:ext cx="653017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3</a:t>
            </a:r>
            <a:r>
              <a:rPr lang="en-GB" sz="1200" dirty="0"/>
              <a:t>. A, B : (</a:t>
            </a:r>
            <a:r>
              <a:rPr lang="en-GB" sz="1200" dirty="0" err="1"/>
              <a:t>i</a:t>
            </a:r>
            <a:r>
              <a:rPr lang="en-GB" sz="1200" dirty="0"/>
              <a:t>) LC3b I, (ii)II and (iii) LC3bII/I densitometry analyses from western blots performed on 2 independent IPF/control cohorts, C and D : relative mRNA expression of p62 and Beclin1. E. Representative images of LC3b </a:t>
            </a:r>
            <a:r>
              <a:rPr lang="en-GB" sz="1200" dirty="0" err="1"/>
              <a:t>immunostained</a:t>
            </a:r>
            <a:r>
              <a:rPr lang="en-GB" sz="1200" dirty="0"/>
              <a:t> alveolar macrophages from IPF and control samples treated with CQ or left untreated. All graphs represent median and interquartile ranges, no significant differences observed according to Mann-Whitney test.</a:t>
            </a:r>
          </a:p>
          <a:p>
            <a:pPr algn="just"/>
            <a:endParaRPr lang="en-GB" sz="1200" dirty="0"/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DE1EC8F2-CC88-0F46-82F0-89D9B3E00A2A}"/>
              </a:ext>
            </a:extLst>
          </p:cNvPr>
          <p:cNvGrpSpPr/>
          <p:nvPr/>
        </p:nvGrpSpPr>
        <p:grpSpPr>
          <a:xfrm>
            <a:off x="197070" y="6391743"/>
            <a:ext cx="6322747" cy="1994849"/>
            <a:chOff x="67715" y="134854"/>
            <a:chExt cx="6322747" cy="1994849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28318AF-DCE1-A54D-9422-81A52C2FE50B}"/>
                </a:ext>
              </a:extLst>
            </p:cNvPr>
            <p:cNvSpPr txBox="1"/>
            <p:nvPr/>
          </p:nvSpPr>
          <p:spPr>
            <a:xfrm>
              <a:off x="1880147" y="134854"/>
              <a:ext cx="645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Control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FC47F37-D184-E244-9C9D-3A4AD7C11125}"/>
                </a:ext>
              </a:extLst>
            </p:cNvPr>
            <p:cNvSpPr txBox="1"/>
            <p:nvPr/>
          </p:nvSpPr>
          <p:spPr>
            <a:xfrm>
              <a:off x="5043744" y="134854"/>
              <a:ext cx="3738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IPF</a:t>
              </a:r>
            </a:p>
          </p:txBody>
        </p: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E22E6DB3-4613-CA48-A34C-CD781306706B}"/>
                </a:ext>
              </a:extLst>
            </p:cNvPr>
            <p:cNvGrpSpPr/>
            <p:nvPr/>
          </p:nvGrpSpPr>
          <p:grpSpPr>
            <a:xfrm>
              <a:off x="152776" y="462027"/>
              <a:ext cx="6237686" cy="1667676"/>
              <a:chOff x="189258" y="7892097"/>
              <a:chExt cx="6237686" cy="1667676"/>
            </a:xfrm>
          </p:grpSpPr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1D9573A3-C0CB-3143-A965-07F30E9BEF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953469" y="8119773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41E748DC-50E5-DE4E-8289-67BDEB5313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986944" y="8115952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172F3246-B7AD-174F-8943-8C83C0E97AA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76557" y="8117108"/>
                <a:ext cx="1440000" cy="1440000"/>
              </a:xfrm>
              <a:prstGeom prst="rect">
                <a:avLst/>
              </a:prstGeom>
            </p:spPr>
          </p:pic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B9C59F03-738D-7549-8CB6-1931CDE4D0A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506145" y="8113598"/>
                <a:ext cx="1440000" cy="1440000"/>
              </a:xfrm>
              <a:prstGeom prst="rect">
                <a:avLst/>
              </a:prstGeom>
            </p:spPr>
          </p:pic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id="{F2E14809-13A1-C347-8EF8-1E331D366E7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1487" y="7926313"/>
                <a:ext cx="2920528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76D31DFF-AB5E-714D-8606-8B8A8998FDC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97763" y="7926313"/>
                <a:ext cx="2920528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44 - TextBox">
                <a:extLst>
                  <a:ext uri="{FF2B5EF4-FFF2-40B4-BE49-F238E27FC236}">
                    <a16:creationId xmlns:a16="http://schemas.microsoft.com/office/drawing/2014/main" id="{820044BA-F7D7-BD4A-B9FA-BFD172D8A5A7}"/>
                  </a:ext>
                </a:extLst>
              </p:cNvPr>
              <p:cNvSpPr txBox="1"/>
              <p:nvPr/>
            </p:nvSpPr>
            <p:spPr>
              <a:xfrm>
                <a:off x="476557" y="7893142"/>
                <a:ext cx="29054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NT                                   CQ</a:t>
                </a:r>
              </a:p>
            </p:txBody>
          </p:sp>
          <p:sp>
            <p:nvSpPr>
              <p:cNvPr id="31" name="44 - TextBox">
                <a:extLst>
                  <a:ext uri="{FF2B5EF4-FFF2-40B4-BE49-F238E27FC236}">
                    <a16:creationId xmlns:a16="http://schemas.microsoft.com/office/drawing/2014/main" id="{55BD4561-1308-4C43-BDE5-6B8048CBC5C4}"/>
                  </a:ext>
                </a:extLst>
              </p:cNvPr>
              <p:cNvSpPr txBox="1"/>
              <p:nvPr/>
            </p:nvSpPr>
            <p:spPr>
              <a:xfrm>
                <a:off x="3504952" y="7892097"/>
                <a:ext cx="29054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/>
                  <a:t>NT                                   CQ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AAD444C6-3A04-0D42-9F31-9913BB6EE1D1}"/>
                  </a:ext>
                </a:extLst>
              </p:cNvPr>
              <p:cNvSpPr txBox="1"/>
              <p:nvPr/>
            </p:nvSpPr>
            <p:spPr>
              <a:xfrm rot="16200000">
                <a:off x="82370" y="8670345"/>
                <a:ext cx="4907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dirty="0"/>
                  <a:t>LC3B</a:t>
                </a:r>
              </a:p>
            </p:txBody>
          </p:sp>
        </p:grp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610F467-BD8B-924E-9876-0A2031D72E25}"/>
                </a:ext>
              </a:extLst>
            </p:cNvPr>
            <p:cNvSpPr txBox="1"/>
            <p:nvPr/>
          </p:nvSpPr>
          <p:spPr>
            <a:xfrm>
              <a:off x="67715" y="221762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Arial" panose="020B0604020202020204" pitchFamily="34" charset="0"/>
                  <a:cs typeface="Arial" panose="020B0604020202020204" pitchFamily="34" charset="0"/>
                </a:rPr>
                <a:t>E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473531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3</TotalTime>
  <Words>214</Words>
  <Application>Microsoft Macintosh PowerPoint</Application>
  <PresentationFormat>A4 Paper (210x297 mm)</PresentationFormat>
  <Paragraphs>1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70</cp:revision>
  <dcterms:created xsi:type="dcterms:W3CDTF">2018-07-18T09:30:46Z</dcterms:created>
  <dcterms:modified xsi:type="dcterms:W3CDTF">2019-01-15T14:33:44Z</dcterms:modified>
</cp:coreProperties>
</file>